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1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506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3981-6304-4148-9113-D8F252AC8A72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1D70E-EBC3-480F-AD00-B2665D4659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12327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3981-6304-4148-9113-D8F252AC8A72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1D70E-EBC3-480F-AD00-B2665D4659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31974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3981-6304-4148-9113-D8F252AC8A72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1D70E-EBC3-480F-AD00-B2665D4659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86756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3981-6304-4148-9113-D8F252AC8A72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1D70E-EBC3-480F-AD00-B2665D4659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04853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3981-6304-4148-9113-D8F252AC8A72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1D70E-EBC3-480F-AD00-B2665D4659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11820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3981-6304-4148-9113-D8F252AC8A72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1D70E-EBC3-480F-AD00-B2665D4659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01379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3981-6304-4148-9113-D8F252AC8A72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1D70E-EBC3-480F-AD00-B2665D4659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66323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3981-6304-4148-9113-D8F252AC8A72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1D70E-EBC3-480F-AD00-B2665D4659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92588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3981-6304-4148-9113-D8F252AC8A72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1D70E-EBC3-480F-AD00-B2665D4659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40593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3981-6304-4148-9113-D8F252AC8A72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1D70E-EBC3-480F-AD00-B2665D4659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90185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3981-6304-4148-9113-D8F252AC8A72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1D70E-EBC3-480F-AD00-B2665D4659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79153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AF3981-6304-4148-9113-D8F252AC8A72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E1D70E-EBC3-480F-AD00-B2665D4659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87075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emf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7" name="Group 66">
            <a:extLst>
              <a:ext uri="{FF2B5EF4-FFF2-40B4-BE49-F238E27FC236}">
                <a16:creationId xmlns:a16="http://schemas.microsoft.com/office/drawing/2014/main" id="{03282919-E7ED-4950-B449-1AE8FB6C823D}"/>
              </a:ext>
            </a:extLst>
          </p:cNvPr>
          <p:cNvGrpSpPr/>
          <p:nvPr/>
        </p:nvGrpSpPr>
        <p:grpSpPr>
          <a:xfrm>
            <a:off x="511731" y="504745"/>
            <a:ext cx="8114859" cy="6065235"/>
            <a:chOff x="-8389" y="689301"/>
            <a:chExt cx="8114859" cy="6065235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90B4CB18-8E46-491E-B41D-0097B2B8564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5413" t="7478" r="3211" b="13971"/>
            <a:stretch/>
          </p:blipFill>
          <p:spPr>
            <a:xfrm>
              <a:off x="100247" y="2090539"/>
              <a:ext cx="2633357" cy="4629043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ADC0243D-22A0-4E42-A542-EC2E4078AC5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b="92522"/>
            <a:stretch/>
          </p:blipFill>
          <p:spPr>
            <a:xfrm>
              <a:off x="-8389" y="1073791"/>
              <a:ext cx="2776759" cy="264869"/>
            </a:xfrm>
            <a:prstGeom prst="rect">
              <a:avLst/>
            </a:prstGeom>
          </p:spPr>
        </p:pic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29B0B0E8-544C-439E-935C-0CC4855D7FB1}"/>
                </a:ext>
              </a:extLst>
            </p:cNvPr>
            <p:cNvGrpSpPr/>
            <p:nvPr/>
          </p:nvGrpSpPr>
          <p:grpSpPr>
            <a:xfrm>
              <a:off x="74174" y="1243947"/>
              <a:ext cx="2685505" cy="957475"/>
              <a:chOff x="511727" y="1844866"/>
              <a:chExt cx="2592201" cy="940093"/>
            </a:xfrm>
          </p:grpSpPr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6CC55EB9-FB3E-4F5C-9EE1-E538C12459B9}"/>
                  </a:ext>
                </a:extLst>
              </p:cNvPr>
              <p:cNvSpPr txBox="1"/>
              <p:nvPr/>
            </p:nvSpPr>
            <p:spPr>
              <a:xfrm rot="16200000">
                <a:off x="250307" y="2161024"/>
                <a:ext cx="83061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Gy-72h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00C44FCF-38D1-4775-9254-81162D236978}"/>
                  </a:ext>
                </a:extLst>
              </p:cNvPr>
              <p:cNvSpPr txBox="1"/>
              <p:nvPr/>
            </p:nvSpPr>
            <p:spPr>
              <a:xfrm rot="16200000">
                <a:off x="503375" y="2161024"/>
                <a:ext cx="83061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Gy-72h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5513F31E-10D5-464D-97AA-86931FC375DC}"/>
                  </a:ext>
                </a:extLst>
              </p:cNvPr>
              <p:cNvSpPr txBox="1"/>
              <p:nvPr/>
            </p:nvSpPr>
            <p:spPr>
              <a:xfrm rot="16200000">
                <a:off x="701706" y="2161024"/>
                <a:ext cx="94009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Gy-72h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E4335D98-69B6-4A5B-AB18-469B0EDD7D54}"/>
                  </a:ext>
                </a:extLst>
              </p:cNvPr>
              <p:cNvSpPr txBox="1"/>
              <p:nvPr/>
            </p:nvSpPr>
            <p:spPr>
              <a:xfrm rot="16200000">
                <a:off x="996927" y="2161024"/>
                <a:ext cx="83061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Gy-24h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0B18F5C3-F801-464B-8D72-5D6AD139C5C6}"/>
                  </a:ext>
                </a:extLst>
              </p:cNvPr>
              <p:cNvSpPr txBox="1"/>
              <p:nvPr/>
            </p:nvSpPr>
            <p:spPr>
              <a:xfrm rot="16200000">
                <a:off x="1202184" y="2161024"/>
                <a:ext cx="83061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Gy-24h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A108CFC3-D124-437E-96E4-B77FE6B9A4CB}"/>
                  </a:ext>
                </a:extLst>
              </p:cNvPr>
              <p:cNvSpPr txBox="1"/>
              <p:nvPr/>
            </p:nvSpPr>
            <p:spPr>
              <a:xfrm rot="16200000">
                <a:off x="1416157" y="2161024"/>
                <a:ext cx="90582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Gy-24h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75359157-616F-4651-978D-8305EB92E7CF}"/>
                  </a:ext>
                </a:extLst>
              </p:cNvPr>
              <p:cNvSpPr txBox="1"/>
              <p:nvPr/>
            </p:nvSpPr>
            <p:spPr>
              <a:xfrm rot="16200000">
                <a:off x="1745613" y="2161024"/>
                <a:ext cx="83061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Gy-24h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56D4E7D2-C2D2-435B-AFA6-4CB745536BB4}"/>
                  </a:ext>
                </a:extLst>
              </p:cNvPr>
              <p:cNvSpPr txBox="1"/>
              <p:nvPr/>
            </p:nvSpPr>
            <p:spPr>
              <a:xfrm rot="16200000">
                <a:off x="1978423" y="2161024"/>
                <a:ext cx="83061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Gy-24h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BD8F293D-5FE2-4438-9014-93776FADC827}"/>
                  </a:ext>
                </a:extLst>
              </p:cNvPr>
              <p:cNvSpPr txBox="1"/>
              <p:nvPr/>
            </p:nvSpPr>
            <p:spPr>
              <a:xfrm rot="16200000">
                <a:off x="2270276" y="2161024"/>
                <a:ext cx="83061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Gy-72h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22D31788-0E45-43FB-BC85-51D521B9D732}"/>
                  </a:ext>
                </a:extLst>
              </p:cNvPr>
              <p:cNvSpPr txBox="1"/>
              <p:nvPr/>
            </p:nvSpPr>
            <p:spPr>
              <a:xfrm rot="16200000">
                <a:off x="2534731" y="2161024"/>
                <a:ext cx="83061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Gy-72h</a:t>
                </a:r>
              </a:p>
            </p:txBody>
          </p:sp>
        </p:grp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FF259CED-3C6E-479A-A7CA-8AA205306958}"/>
                </a:ext>
              </a:extLst>
            </p:cNvPr>
            <p:cNvSpPr txBox="1"/>
            <p:nvPr/>
          </p:nvSpPr>
          <p:spPr>
            <a:xfrm flipH="1">
              <a:off x="-2615" y="721452"/>
              <a:ext cx="23695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A                </a:t>
              </a:r>
              <a:r>
                <a:rPr lang="en-US" sz="1600" dirty="0"/>
                <a:t>mRNA</a:t>
              </a:r>
              <a:endParaRPr lang="en-US" dirty="0"/>
            </a:p>
          </p:txBody>
        </p: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33273394-D6CA-4C11-999B-3FB2CD078ACD}"/>
                </a:ext>
              </a:extLst>
            </p:cNvPr>
            <p:cNvCxnSpPr/>
            <p:nvPr/>
          </p:nvCxnSpPr>
          <p:spPr>
            <a:xfrm>
              <a:off x="2768370" y="755009"/>
              <a:ext cx="0" cy="598974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D382833C-87AC-4F3F-A617-F3546F73C94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025" t="7285" r="3396" b="15761"/>
            <a:stretch/>
          </p:blipFill>
          <p:spPr>
            <a:xfrm>
              <a:off x="2818704" y="2172748"/>
              <a:ext cx="2541865" cy="4546833"/>
            </a:xfrm>
            <a:prstGeom prst="rect">
              <a:avLst/>
            </a:prstGeom>
          </p:spPr>
        </p:pic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41A99E74-1774-49E1-B97F-462746587B6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8552" t="-1139" r="6967" b="93003"/>
            <a:stretch/>
          </p:blipFill>
          <p:spPr>
            <a:xfrm>
              <a:off x="2819569" y="1090784"/>
              <a:ext cx="2341559" cy="302004"/>
            </a:xfrm>
            <a:prstGeom prst="rect">
              <a:avLst/>
            </a:prstGeom>
          </p:spPr>
        </p:pic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id="{B7C4E8B4-9219-4038-A403-846BBA09BA90}"/>
                </a:ext>
              </a:extLst>
            </p:cNvPr>
            <p:cNvGrpSpPr/>
            <p:nvPr/>
          </p:nvGrpSpPr>
          <p:grpSpPr>
            <a:xfrm>
              <a:off x="2751865" y="1282915"/>
              <a:ext cx="2685505" cy="990504"/>
              <a:chOff x="511727" y="1790128"/>
              <a:chExt cx="2592201" cy="972521"/>
            </a:xfrm>
          </p:grpSpPr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55A9D58B-3058-4116-ACA9-990AE170FC1C}"/>
                  </a:ext>
                </a:extLst>
              </p:cNvPr>
              <p:cNvSpPr txBox="1"/>
              <p:nvPr/>
            </p:nvSpPr>
            <p:spPr>
              <a:xfrm rot="16200000">
                <a:off x="250307" y="2161024"/>
                <a:ext cx="83061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Gy-72h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98B2DB76-2395-4681-B161-7A690D794C01}"/>
                  </a:ext>
                </a:extLst>
              </p:cNvPr>
              <p:cNvSpPr txBox="1"/>
              <p:nvPr/>
            </p:nvSpPr>
            <p:spPr>
              <a:xfrm rot="16200000">
                <a:off x="448637" y="2111633"/>
                <a:ext cx="940094" cy="2970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Gy-72h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6986FDB2-EED1-4CAC-9209-B24E7DB93024}"/>
                  </a:ext>
                </a:extLst>
              </p:cNvPr>
              <p:cNvSpPr txBox="1"/>
              <p:nvPr/>
            </p:nvSpPr>
            <p:spPr>
              <a:xfrm rot="16200000">
                <a:off x="701706" y="2111604"/>
                <a:ext cx="94009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Gy-24h</a:t>
                </a: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0369A776-8F05-41E1-8376-DA4B724B7496}"/>
                  </a:ext>
                </a:extLst>
              </p:cNvPr>
              <p:cNvSpPr txBox="1"/>
              <p:nvPr/>
            </p:nvSpPr>
            <p:spPr>
              <a:xfrm rot="16200000">
                <a:off x="996927" y="2161024"/>
                <a:ext cx="83061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Gy-24h</a:t>
                </a: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4ACEE48E-0488-45E7-B6F9-479F0E0DA163}"/>
                  </a:ext>
                </a:extLst>
              </p:cNvPr>
              <p:cNvSpPr txBox="1"/>
              <p:nvPr/>
            </p:nvSpPr>
            <p:spPr>
              <a:xfrm rot="16200000">
                <a:off x="1218360" y="2177237"/>
                <a:ext cx="86304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Gy-24h</a:t>
                </a: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64D493D0-6817-49EF-A4AE-2B03C58452C4}"/>
                  </a:ext>
                </a:extLst>
              </p:cNvPr>
              <p:cNvSpPr txBox="1"/>
              <p:nvPr/>
            </p:nvSpPr>
            <p:spPr>
              <a:xfrm rot="16200000">
                <a:off x="1440449" y="2128077"/>
                <a:ext cx="90582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Gy-24h</a:t>
                </a: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750CFCB7-A945-4BA6-9358-976F4C2FFDB3}"/>
                  </a:ext>
                </a:extLst>
              </p:cNvPr>
              <p:cNvSpPr txBox="1"/>
              <p:nvPr/>
            </p:nvSpPr>
            <p:spPr>
              <a:xfrm rot="16200000">
                <a:off x="1691017" y="2128109"/>
                <a:ext cx="923613" cy="2970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Gy-24h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6BC2F6C0-DAA8-494F-913D-D7FA62879E81}"/>
                  </a:ext>
                </a:extLst>
              </p:cNvPr>
              <p:cNvSpPr txBox="1"/>
              <p:nvPr/>
            </p:nvSpPr>
            <p:spPr>
              <a:xfrm rot="16200000">
                <a:off x="1978423" y="2161024"/>
                <a:ext cx="83061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Gy-72h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49F770B5-A4B1-406B-9ECA-609C18917368}"/>
                  </a:ext>
                </a:extLst>
              </p:cNvPr>
              <p:cNvSpPr txBox="1"/>
              <p:nvPr/>
            </p:nvSpPr>
            <p:spPr>
              <a:xfrm rot="16200000">
                <a:off x="2270276" y="2161024"/>
                <a:ext cx="83061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Gy-72h</a:t>
                </a: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359CF871-38DB-45AB-88DF-2CE6317FCAD4}"/>
                  </a:ext>
                </a:extLst>
              </p:cNvPr>
              <p:cNvSpPr txBox="1"/>
              <p:nvPr/>
            </p:nvSpPr>
            <p:spPr>
              <a:xfrm rot="16200000">
                <a:off x="2534731" y="2161024"/>
                <a:ext cx="83061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Gy-72h</a:t>
                </a:r>
              </a:p>
            </p:txBody>
          </p:sp>
        </p:grp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A750CD8C-A0AB-45C0-BCCA-408CCDB5B01E}"/>
                </a:ext>
              </a:extLst>
            </p:cNvPr>
            <p:cNvSpPr txBox="1"/>
            <p:nvPr/>
          </p:nvSpPr>
          <p:spPr>
            <a:xfrm flipH="1">
              <a:off x="2751866" y="721452"/>
              <a:ext cx="192919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B             </a:t>
              </a:r>
              <a:r>
                <a:rPr lang="en-US" sz="1600" dirty="0"/>
                <a:t>lncRNA</a:t>
              </a:r>
              <a:endParaRPr lang="en-US" dirty="0"/>
            </a:p>
          </p:txBody>
        </p:sp>
        <p:cxnSp>
          <p:nvCxnSpPr>
            <p:cNvPr id="39" name="Straight Connector 38">
              <a:extLst>
                <a:ext uri="{FF2B5EF4-FFF2-40B4-BE49-F238E27FC236}">
                  <a16:creationId xmlns:a16="http://schemas.microsoft.com/office/drawing/2014/main" id="{6D15505D-EAA0-4E57-9F54-25A8D57E2B71}"/>
                </a:ext>
              </a:extLst>
            </p:cNvPr>
            <p:cNvCxnSpPr/>
            <p:nvPr/>
          </p:nvCxnSpPr>
          <p:spPr>
            <a:xfrm>
              <a:off x="5395525" y="764796"/>
              <a:ext cx="0" cy="598974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41" name="Picture 40">
              <a:extLst>
                <a:ext uri="{FF2B5EF4-FFF2-40B4-BE49-F238E27FC236}">
                  <a16:creationId xmlns:a16="http://schemas.microsoft.com/office/drawing/2014/main" id="{975ACA70-9818-433A-87A6-BEE32BC458D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5920" t="8305" r="2936" b="15256"/>
            <a:stretch/>
          </p:blipFill>
          <p:spPr>
            <a:xfrm>
              <a:off x="5443740" y="2164360"/>
              <a:ext cx="2650737" cy="4567203"/>
            </a:xfrm>
            <a:prstGeom prst="rect">
              <a:avLst/>
            </a:prstGeom>
          </p:spPr>
        </p:pic>
        <p:grpSp>
          <p:nvGrpSpPr>
            <p:cNvPr id="42" name="Group 41">
              <a:extLst>
                <a:ext uri="{FF2B5EF4-FFF2-40B4-BE49-F238E27FC236}">
                  <a16:creationId xmlns:a16="http://schemas.microsoft.com/office/drawing/2014/main" id="{A3CA734A-6539-4C03-8340-42A025C7EB6A}"/>
                </a:ext>
              </a:extLst>
            </p:cNvPr>
            <p:cNvGrpSpPr/>
            <p:nvPr/>
          </p:nvGrpSpPr>
          <p:grpSpPr>
            <a:xfrm>
              <a:off x="5420965" y="1284313"/>
              <a:ext cx="2685505" cy="990504"/>
              <a:chOff x="511727" y="1790128"/>
              <a:chExt cx="2592201" cy="972521"/>
            </a:xfrm>
          </p:grpSpPr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A59E4DC5-00B1-458C-A004-36FCE81D9459}"/>
                  </a:ext>
                </a:extLst>
              </p:cNvPr>
              <p:cNvSpPr txBox="1"/>
              <p:nvPr/>
            </p:nvSpPr>
            <p:spPr>
              <a:xfrm rot="16200000">
                <a:off x="250307" y="2161024"/>
                <a:ext cx="83061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Gy-72h</a:t>
                </a: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37A05564-B93A-47F7-89A6-8660F2BC39FE}"/>
                  </a:ext>
                </a:extLst>
              </p:cNvPr>
              <p:cNvSpPr txBox="1"/>
              <p:nvPr/>
            </p:nvSpPr>
            <p:spPr>
              <a:xfrm rot="16200000">
                <a:off x="448637" y="2111633"/>
                <a:ext cx="940094" cy="2970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Gy-72h</a:t>
                </a:r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AC444EF7-2E81-427B-BF9F-9F973524266F}"/>
                  </a:ext>
                </a:extLst>
              </p:cNvPr>
              <p:cNvSpPr txBox="1"/>
              <p:nvPr/>
            </p:nvSpPr>
            <p:spPr>
              <a:xfrm rot="16200000">
                <a:off x="701706" y="2111604"/>
                <a:ext cx="94009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Gy-24h</a:t>
                </a:r>
              </a:p>
            </p:txBody>
          </p: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D7E8AAD4-7579-4286-B6BF-8889EB452547}"/>
                  </a:ext>
                </a:extLst>
              </p:cNvPr>
              <p:cNvSpPr txBox="1"/>
              <p:nvPr/>
            </p:nvSpPr>
            <p:spPr>
              <a:xfrm rot="16200000">
                <a:off x="996927" y="2161024"/>
                <a:ext cx="83061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Gy-24h</a:t>
                </a:r>
              </a:p>
            </p:txBody>
          </p: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CCF07DF1-4471-4489-BD7E-88871C4EBC3F}"/>
                  </a:ext>
                </a:extLst>
              </p:cNvPr>
              <p:cNvSpPr txBox="1"/>
              <p:nvPr/>
            </p:nvSpPr>
            <p:spPr>
              <a:xfrm rot="16200000">
                <a:off x="1218360" y="2177237"/>
                <a:ext cx="86304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Gy-24h</a:t>
                </a:r>
              </a:p>
            </p:txBody>
          </p:sp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6B0B8A96-2027-4F76-8780-894256299669}"/>
                  </a:ext>
                </a:extLst>
              </p:cNvPr>
              <p:cNvSpPr txBox="1"/>
              <p:nvPr/>
            </p:nvSpPr>
            <p:spPr>
              <a:xfrm rot="16200000">
                <a:off x="1440449" y="2128077"/>
                <a:ext cx="90582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Gy-24h</a:t>
                </a:r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97C3A9DD-4D56-4490-9DC3-00DFB707EA2F}"/>
                  </a:ext>
                </a:extLst>
              </p:cNvPr>
              <p:cNvSpPr txBox="1"/>
              <p:nvPr/>
            </p:nvSpPr>
            <p:spPr>
              <a:xfrm rot="16200000">
                <a:off x="1691017" y="2128109"/>
                <a:ext cx="923613" cy="2970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Gy-24h</a:t>
                </a:r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7433416C-2908-4076-A11C-C947155A4834}"/>
                  </a:ext>
                </a:extLst>
              </p:cNvPr>
              <p:cNvSpPr txBox="1"/>
              <p:nvPr/>
            </p:nvSpPr>
            <p:spPr>
              <a:xfrm rot="16200000">
                <a:off x="1978423" y="2161024"/>
                <a:ext cx="83061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Gy-72h</a:t>
                </a:r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1415A340-B943-4571-9A3B-206D2343578B}"/>
                  </a:ext>
                </a:extLst>
              </p:cNvPr>
              <p:cNvSpPr txBox="1"/>
              <p:nvPr/>
            </p:nvSpPr>
            <p:spPr>
              <a:xfrm rot="16200000">
                <a:off x="2270276" y="2161024"/>
                <a:ext cx="83061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Gy-72h</a:t>
                </a: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58BCA7D6-E685-4A31-AEAC-217A45B5B93A}"/>
                  </a:ext>
                </a:extLst>
              </p:cNvPr>
              <p:cNvSpPr txBox="1"/>
              <p:nvPr/>
            </p:nvSpPr>
            <p:spPr>
              <a:xfrm rot="16200000">
                <a:off x="2534731" y="2161024"/>
                <a:ext cx="83061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Gy-72h</a:t>
                </a:r>
              </a:p>
            </p:txBody>
          </p:sp>
        </p:grpSp>
        <p:pic>
          <p:nvPicPr>
            <p:cNvPr id="65" name="Picture 64">
              <a:extLst>
                <a:ext uri="{FF2B5EF4-FFF2-40B4-BE49-F238E27FC236}">
                  <a16:creationId xmlns:a16="http://schemas.microsoft.com/office/drawing/2014/main" id="{EBEEC2B6-C782-4ACE-ABE2-22FB698C869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6113" t="-4152" r="4589" b="92863"/>
            <a:stretch/>
          </p:blipFill>
          <p:spPr>
            <a:xfrm>
              <a:off x="5432795" y="981512"/>
              <a:ext cx="2624652" cy="421292"/>
            </a:xfrm>
            <a:prstGeom prst="rect">
              <a:avLst/>
            </a:prstGeom>
          </p:spPr>
        </p:pic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77B2745B-06F0-4CAD-AD32-70F5CC032AA8}"/>
                </a:ext>
              </a:extLst>
            </p:cNvPr>
            <p:cNvSpPr txBox="1"/>
            <p:nvPr/>
          </p:nvSpPr>
          <p:spPr>
            <a:xfrm flipH="1">
              <a:off x="5356967" y="689301"/>
              <a:ext cx="201695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C              </a:t>
              </a:r>
              <a:r>
                <a:rPr lang="en-US" sz="1600" dirty="0"/>
                <a:t>miRNA</a:t>
              </a:r>
              <a:endParaRPr lang="en-US" dirty="0"/>
            </a:p>
          </p:txBody>
        </p:sp>
      </p:grpSp>
      <p:sp>
        <p:nvSpPr>
          <p:cNvPr id="53" name="TextBox 52">
            <a:extLst>
              <a:ext uri="{FF2B5EF4-FFF2-40B4-BE49-F238E27FC236}">
                <a16:creationId xmlns:a16="http://schemas.microsoft.com/office/drawing/2014/main" id="{52906E91-2117-4385-8327-C20240DB6907}"/>
              </a:ext>
            </a:extLst>
          </p:cNvPr>
          <p:cNvSpPr txBox="1"/>
          <p:nvPr/>
        </p:nvSpPr>
        <p:spPr>
          <a:xfrm>
            <a:off x="1013919" y="-47938"/>
            <a:ext cx="7193235" cy="67191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: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Heatmaps for differentially expressed A) mRNAs, B) </a:t>
            </a:r>
            <a:r>
              <a:rPr lang="en-US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ncRNAs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C) miRNAs based on ANOVA (FDR&lt;0.05)</a:t>
            </a:r>
          </a:p>
        </p:txBody>
      </p:sp>
    </p:spTree>
    <p:extLst>
      <p:ext uri="{BB962C8B-B14F-4D97-AF65-F5344CB8AC3E}">
        <p14:creationId xmlns:p14="http://schemas.microsoft.com/office/powerpoint/2010/main" val="42266713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</TotalTime>
  <Words>63</Words>
  <Application>Microsoft Office PowerPoint</Application>
  <PresentationFormat>On-screen Show (4:3)</PresentationFormat>
  <Paragraphs>3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opra, Sunita (NIH/NCI) [F]</dc:creator>
  <cp:lastModifiedBy>Chopra, Sunita (NIH/NCI) [F]</cp:lastModifiedBy>
  <cp:revision>10</cp:revision>
  <dcterms:created xsi:type="dcterms:W3CDTF">2022-04-27T15:24:14Z</dcterms:created>
  <dcterms:modified xsi:type="dcterms:W3CDTF">2022-08-10T14:26:55Z</dcterms:modified>
</cp:coreProperties>
</file>